
<file path=[Content_Types].xml><?xml version="1.0" encoding="utf-8"?>
<Types xmlns="http://schemas.openxmlformats.org/package/2006/content-types"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12" d="100"/>
          <a:sy n="112" d="100"/>
        </p:scale>
        <p:origin x="51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493A17-1856-30E3-D7D5-F5C7F9631A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C901F8F-DAE8-DC33-79A2-01FE3C3724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64BE76A-66A6-EF4D-D6A4-A1C7B68FE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5D0BDD-8130-5196-190D-93927E0D8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C84E6F0-843B-B977-F6D9-3A64C6A31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0048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A9CF133-EE1A-784E-5D8C-C6CE407E8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D443220-61E1-8DE2-34E4-FAD1A47A2A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A430A45-D8DA-5CF9-1564-10A667655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91E6A1-46CF-DA15-3D64-1DDCBE9CE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D147A3A-534D-0449-D048-94DF992B4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4119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A3BFA78-944A-3ED3-5F00-1A25CD542C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BB68C58-AA53-92AF-F96D-5280C61BB1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D105DE-8E61-AEAD-2BEA-D10900F9D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B9A6301-0A98-9882-6DD7-2BF46FD58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FC2CCDA-1D2C-E3C2-4CDE-D5F7767CE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0195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E047F1-2926-1B72-D8F0-C3257C943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F0FB714-AB05-8F3E-736E-7F529B4A59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1BB9950-B1C6-C284-5907-3840E9CC4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AB089C-5882-6322-B795-C290E6937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57FB28-CE5D-2A50-0BD9-5768565F8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062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F979F0-4AF0-AE98-5016-AD1E0035DE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0C5B8F9-700E-DBA9-5CE4-D48D0909A9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E110C9D-CC9F-6090-DDD9-6AC84ABD4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8F36D4-E9C8-E33F-88B3-AA79AF326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EA94805-73B9-F6A8-9897-52CF3A5A1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7492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3BD72E-9645-6694-E43D-CA6B212A74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00BC9D3-9A3F-5872-FE73-7B3E42A2DF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7FEA779-0328-B06E-86AE-B420674B65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E9D03FA-4228-E4A7-A620-AED5CAFD3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F3F51D4-989D-7714-1D9E-015555DA5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CA15EE9-A3B4-24A5-0AD8-FF0C5FA6D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4894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13B212-D9E2-D177-8CF3-2727E068B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5DE4DD3-6B38-3371-0273-80BAE12206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3177CB8-8089-A5E5-74B2-3DB009B462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AB3C8BAB-F1F6-8741-27B0-760930E701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B90A0DF-E67A-4FB0-95AE-B860993DA7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C618B6E-2205-F895-B442-D7AD3BB7E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C9CF91F-9CDD-F961-087F-4C28C22D6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1D627D4-8801-4A79-4155-040F49AD7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571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B66C56-7F94-21C1-52D7-85ED5BAA2D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CE53A66-92C9-9E28-EC03-93A9A4264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AA1D7B0-0BDD-673A-86C6-38D05A4FF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BF420CB-5121-825A-42D7-C8010B827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5895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5B49C6B-BEBD-389D-3DF0-D7FA3E94F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C392DE9-4592-EC5D-8A5F-6FBFE8E8C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BBD71A5-1961-20CD-ED93-00F1248F9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1672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E6C43C-60D2-B559-3B36-1E0D4A007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64C8B21-39E6-EF42-2B1F-B2FFB53516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B6022DF-9A7B-2371-1AB4-0B2FDB9E9F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371CFD9-A73A-EB02-DE67-DD6EC3046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7418725-CFAB-3FAC-6199-30B872A65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5281D32-86E4-6029-9F9E-7C029471F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9725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48A56F-79B3-6A5C-79E2-F5E9D5399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BAD4415-7A6B-D100-8A1B-8345BC71A4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4BD4CFD-C204-619C-62E4-9F77C85DAF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CFB30F1-E37F-7889-FC2A-0E68A519B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72DBBAF-4A47-D6EF-F994-AEA669185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5407B1E-2958-84CD-528C-DF8CA1035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3139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39FEE49-4D08-31F5-FC6E-FDC8470937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DDE177F-DFC9-F0E8-A7C2-83E1014051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D687659-D59A-7091-CF5F-EB5FE089EE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D5B72A-EEB8-7842-957F-CC5BB9BE7B89}" type="datetimeFigureOut">
              <a:rPr lang="es-ES" smtClean="0"/>
              <a:t>27/06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F9899B-1E32-5657-BE64-A320CAE060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0790295-6832-B63A-2FC7-5648F5F4AE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4CBA4-70C8-0E4B-A60E-EC4C63C9C6B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9847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o 14">
            <a:extLst>
              <a:ext uri="{FF2B5EF4-FFF2-40B4-BE49-F238E27FC236}">
                <a16:creationId xmlns:a16="http://schemas.microsoft.com/office/drawing/2014/main" id="{E7A5DDCF-BCF0-E8E4-22DA-2CC4F70EF762}"/>
              </a:ext>
            </a:extLst>
          </p:cNvPr>
          <p:cNvGrpSpPr/>
          <p:nvPr/>
        </p:nvGrpSpPr>
        <p:grpSpPr>
          <a:xfrm>
            <a:off x="1248697" y="1926985"/>
            <a:ext cx="8426417" cy="3270450"/>
            <a:chOff x="3613884" y="1848697"/>
            <a:chExt cx="6061230" cy="2340470"/>
          </a:xfrm>
        </p:grpSpPr>
        <p:pic>
          <p:nvPicPr>
            <p:cNvPr id="16" name="Imagen 15" descr="Gráfico, Gráfico de cajas y bigotes&#10;&#10;Descripción generada automáticamente">
              <a:extLst>
                <a:ext uri="{FF2B5EF4-FFF2-40B4-BE49-F238E27FC236}">
                  <a16:creationId xmlns:a16="http://schemas.microsoft.com/office/drawing/2014/main" id="{12E6F8B7-9A90-CC44-171F-CC30EAB3EA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57" t="-28" r="-457" b="19813"/>
            <a:stretch/>
          </p:blipFill>
          <p:spPr>
            <a:xfrm>
              <a:off x="3613884" y="2134633"/>
              <a:ext cx="3064491" cy="1888922"/>
            </a:xfrm>
            <a:prstGeom prst="rect">
              <a:avLst/>
            </a:prstGeom>
          </p:spPr>
        </p:pic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9575511E-943D-E29A-7942-44B0681997DB}"/>
                </a:ext>
              </a:extLst>
            </p:cNvPr>
            <p:cNvGrpSpPr/>
            <p:nvPr/>
          </p:nvGrpSpPr>
          <p:grpSpPr>
            <a:xfrm>
              <a:off x="3924715" y="1848697"/>
              <a:ext cx="5750399" cy="2340470"/>
              <a:chOff x="3924715" y="1848697"/>
              <a:chExt cx="5750399" cy="2340470"/>
            </a:xfrm>
          </p:grpSpPr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C1517142-C7B2-96A6-C2B7-982E5C8C2D8B}"/>
                  </a:ext>
                </a:extLst>
              </p:cNvPr>
              <p:cNvSpPr txBox="1"/>
              <p:nvPr/>
            </p:nvSpPr>
            <p:spPr>
              <a:xfrm>
                <a:off x="4798830" y="2189549"/>
                <a:ext cx="12603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/>
                  <a:t>P &lt; 0.001</a:t>
                </a: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8DAD25E3-791F-9534-C4E9-FC2E46C19BA1}"/>
                  </a:ext>
                </a:extLst>
              </p:cNvPr>
              <p:cNvSpPr txBox="1"/>
              <p:nvPr/>
            </p:nvSpPr>
            <p:spPr>
              <a:xfrm>
                <a:off x="4422809" y="4012961"/>
                <a:ext cx="333465" cy="1762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 dirty="0"/>
                  <a:t>N=46</a:t>
                </a:r>
              </a:p>
            </p:txBody>
          </p:sp>
          <p:pic>
            <p:nvPicPr>
              <p:cNvPr id="20" name="Imagen 19" descr="Gráfico, Gráfico de cajas y bigotes&#10;&#10;Descripción generada automáticamente">
                <a:extLst>
                  <a:ext uri="{FF2B5EF4-FFF2-40B4-BE49-F238E27FC236}">
                    <a16:creationId xmlns:a16="http://schemas.microsoft.com/office/drawing/2014/main" id="{969FC7A3-E817-B78C-AE08-54CFAF747E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92" t="-1541" r="-392" b="20663"/>
              <a:stretch/>
            </p:blipFill>
            <p:spPr>
              <a:xfrm>
                <a:off x="6167661" y="2072848"/>
                <a:ext cx="3130599" cy="1945615"/>
              </a:xfrm>
              <a:prstGeom prst="rect">
                <a:avLst/>
              </a:prstGeom>
            </p:spPr>
          </p:pic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BF5352DF-8852-7E69-6068-6AE7CB6176D9}"/>
                  </a:ext>
                </a:extLst>
              </p:cNvPr>
              <p:cNvSpPr txBox="1"/>
              <p:nvPr/>
            </p:nvSpPr>
            <p:spPr>
              <a:xfrm>
                <a:off x="7325323" y="2189549"/>
                <a:ext cx="12603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200" dirty="0"/>
                  <a:t>P &lt; 0.001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C4FB0C20-D80F-2A97-0314-12F26AC7A058}"/>
                  </a:ext>
                </a:extLst>
              </p:cNvPr>
              <p:cNvSpPr txBox="1"/>
              <p:nvPr/>
            </p:nvSpPr>
            <p:spPr>
              <a:xfrm>
                <a:off x="7007908" y="4012961"/>
                <a:ext cx="333465" cy="1762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/>
                  <a:t>N=45</a:t>
                </a:r>
              </a:p>
            </p:txBody>
          </p:sp>
          <p:sp>
            <p:nvSpPr>
              <p:cNvPr id="23" name="CuadroTexto 22">
                <a:extLst>
                  <a:ext uri="{FF2B5EF4-FFF2-40B4-BE49-F238E27FC236}">
                    <a16:creationId xmlns:a16="http://schemas.microsoft.com/office/drawing/2014/main" id="{2D4752D9-4409-67A2-B977-B8046ACDA09A}"/>
                  </a:ext>
                </a:extLst>
              </p:cNvPr>
              <p:cNvSpPr txBox="1"/>
              <p:nvPr/>
            </p:nvSpPr>
            <p:spPr>
              <a:xfrm>
                <a:off x="7954753" y="4012961"/>
                <a:ext cx="380741" cy="1762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/>
                  <a:t>N=478</a:t>
                </a:r>
              </a:p>
            </p:txBody>
          </p:sp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172B77B8-CE51-6E80-6117-CC3FC50DBB2A}"/>
                  </a:ext>
                </a:extLst>
              </p:cNvPr>
              <p:cNvSpPr txBox="1"/>
              <p:nvPr/>
            </p:nvSpPr>
            <p:spPr>
              <a:xfrm>
                <a:off x="6532231" y="1848697"/>
                <a:ext cx="314288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400" b="1" dirty="0"/>
                  <a:t>TCGA – LUSC </a:t>
                </a:r>
                <a:r>
                  <a:rPr lang="es-ES_tradnl" sz="1400" b="1" dirty="0" err="1"/>
                  <a:t>Cohort</a:t>
                </a:r>
                <a:endParaRPr lang="es-ES_tradnl" sz="1400" b="1" dirty="0"/>
              </a:p>
            </p:txBody>
          </p:sp>
          <p:sp>
            <p:nvSpPr>
              <p:cNvPr id="25" name="CuadroTexto 24">
                <a:extLst>
                  <a:ext uri="{FF2B5EF4-FFF2-40B4-BE49-F238E27FC236}">
                    <a16:creationId xmlns:a16="http://schemas.microsoft.com/office/drawing/2014/main" id="{ACC75EDE-BD46-5E39-BBC7-ECC15F14640F}"/>
                  </a:ext>
                </a:extLst>
              </p:cNvPr>
              <p:cNvSpPr txBox="1"/>
              <p:nvPr/>
            </p:nvSpPr>
            <p:spPr>
              <a:xfrm>
                <a:off x="3924715" y="1849985"/>
                <a:ext cx="314288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1400" b="1"/>
                  <a:t>TCGA – LUAD Cohort</a:t>
                </a:r>
              </a:p>
            </p:txBody>
          </p:sp>
          <p:sp>
            <p:nvSpPr>
              <p:cNvPr id="26" name="Rectángulo 25">
                <a:extLst>
                  <a:ext uri="{FF2B5EF4-FFF2-40B4-BE49-F238E27FC236}">
                    <a16:creationId xmlns:a16="http://schemas.microsoft.com/office/drawing/2014/main" id="{CA1F298B-2156-7E8B-1869-CDCF4A76606B}"/>
                  </a:ext>
                </a:extLst>
              </p:cNvPr>
              <p:cNvSpPr/>
              <p:nvPr/>
            </p:nvSpPr>
            <p:spPr>
              <a:xfrm>
                <a:off x="5146128" y="3998841"/>
                <a:ext cx="1028529" cy="864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_tradnl"/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1E197AC9-9E3A-2265-B885-4396EBD36862}"/>
                  </a:ext>
                </a:extLst>
              </p:cNvPr>
              <p:cNvSpPr txBox="1"/>
              <p:nvPr/>
            </p:nvSpPr>
            <p:spPr>
              <a:xfrm>
                <a:off x="5339674" y="4012961"/>
                <a:ext cx="380741" cy="1762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00"/>
                  <a:t>N=513</a:t>
                </a:r>
              </a:p>
            </p:txBody>
          </p:sp>
        </p:grpSp>
      </p:grpSp>
      <p:sp>
        <p:nvSpPr>
          <p:cNvPr id="28" name="CuadroTexto 27">
            <a:extLst>
              <a:ext uri="{FF2B5EF4-FFF2-40B4-BE49-F238E27FC236}">
                <a16:creationId xmlns:a16="http://schemas.microsoft.com/office/drawing/2014/main" id="{C72FD4D7-E628-BA7D-7CC7-6F8D45D6AEE7}"/>
              </a:ext>
            </a:extLst>
          </p:cNvPr>
          <p:cNvSpPr txBox="1"/>
          <p:nvPr/>
        </p:nvSpPr>
        <p:spPr>
          <a:xfrm>
            <a:off x="550606" y="452284"/>
            <a:ext cx="3177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</a:t>
            </a:r>
            <a:r>
              <a:rPr lang="es-ES" b="1" dirty="0"/>
              <a:t> Figure S1</a:t>
            </a:r>
          </a:p>
        </p:txBody>
      </p:sp>
    </p:spTree>
    <p:extLst>
      <p:ext uri="{BB962C8B-B14F-4D97-AF65-F5344CB8AC3E}">
        <p14:creationId xmlns:p14="http://schemas.microsoft.com/office/powerpoint/2010/main" val="30411864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161D05AC-5BA3-3BD3-28B7-0657715C84D3}"/>
              </a:ext>
            </a:extLst>
          </p:cNvPr>
          <p:cNvSpPr txBox="1"/>
          <p:nvPr/>
        </p:nvSpPr>
        <p:spPr>
          <a:xfrm>
            <a:off x="550606" y="452284"/>
            <a:ext cx="3177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>
              <a:defRPr b="1"/>
            </a:lvl1pPr>
          </a:lstStyle>
          <a:p>
            <a:r>
              <a:rPr lang="en-US"/>
              <a:t>Supplementary Figure S2</a:t>
            </a:r>
          </a:p>
        </p:txBody>
      </p:sp>
      <p:grpSp>
        <p:nvGrpSpPr>
          <p:cNvPr id="9" name="Grupo 8">
            <a:extLst>
              <a:ext uri="{FF2B5EF4-FFF2-40B4-BE49-F238E27FC236}">
                <a16:creationId xmlns:a16="http://schemas.microsoft.com/office/drawing/2014/main" id="{24BE80BA-CA1B-4C63-896A-619C011A48DA}"/>
              </a:ext>
            </a:extLst>
          </p:cNvPr>
          <p:cNvGrpSpPr/>
          <p:nvPr/>
        </p:nvGrpSpPr>
        <p:grpSpPr>
          <a:xfrm>
            <a:off x="620021" y="1327354"/>
            <a:ext cx="10072543" cy="4970207"/>
            <a:chOff x="620021" y="1327354"/>
            <a:chExt cx="10072543" cy="4970207"/>
          </a:xfrm>
        </p:grpSpPr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B866024A-A13F-FD93-080B-CC46927632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20021" y="1327354"/>
              <a:ext cx="4881112" cy="4970207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0C3EAC36-0FC5-CCA1-2D6E-6CB12A0B5C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11452" y="1327354"/>
              <a:ext cx="4881112" cy="49702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656295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32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fons Navarro Ponz</dc:creator>
  <cp:lastModifiedBy>MDPI</cp:lastModifiedBy>
  <cp:revision>4</cp:revision>
  <dcterms:created xsi:type="dcterms:W3CDTF">2022-06-17T13:33:50Z</dcterms:created>
  <dcterms:modified xsi:type="dcterms:W3CDTF">2022-06-27T13:35:38Z</dcterms:modified>
</cp:coreProperties>
</file>